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1343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694"/>
  </p:normalViewPr>
  <p:slideViewPr>
    <p:cSldViewPr snapToGrid="0" snapToObjects="1">
      <p:cViewPr varScale="1">
        <p:scale>
          <a:sx n="65" d="100"/>
          <a:sy n="65" d="100"/>
        </p:scale>
        <p:origin x="253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92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021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923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498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994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781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940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38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981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43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6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599F8-9672-0E46-8C12-39EDC081D83E}" type="datetimeFigureOut">
              <a:rPr lang="en-US" smtClean="0"/>
              <a:t>3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E61B2-B684-B644-AC75-7C753F130F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29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4719404-573F-2DAC-27A9-D93FD49BE957}"/>
              </a:ext>
            </a:extLst>
          </p:cNvPr>
          <p:cNvSpPr txBox="1"/>
          <p:nvPr/>
        </p:nvSpPr>
        <p:spPr>
          <a:xfrm>
            <a:off x="317621" y="2182616"/>
            <a:ext cx="828795" cy="229743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UPP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FC19316-A29C-E9D2-E530-C28C912B3EDB}"/>
              </a:ext>
            </a:extLst>
          </p:cNvPr>
          <p:cNvSpPr txBox="1"/>
          <p:nvPr/>
        </p:nvSpPr>
        <p:spPr>
          <a:xfrm>
            <a:off x="466528" y="5112472"/>
            <a:ext cx="767640" cy="22974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9DC347A-220C-6456-CD08-CF307E828A3E}"/>
              </a:ext>
            </a:extLst>
          </p:cNvPr>
          <p:cNvSpPr txBox="1"/>
          <p:nvPr/>
        </p:nvSpPr>
        <p:spPr>
          <a:xfrm>
            <a:off x="3903449" y="2068684"/>
            <a:ext cx="580534" cy="229743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6BC567F-69F5-27F7-F96B-BEBA22DF465B}"/>
              </a:ext>
            </a:extLst>
          </p:cNvPr>
          <p:cNvSpPr txBox="1"/>
          <p:nvPr/>
        </p:nvSpPr>
        <p:spPr>
          <a:xfrm>
            <a:off x="3632387" y="3056841"/>
            <a:ext cx="820202" cy="229743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FFC1C5-673B-1D20-EAE9-482E995D1648}"/>
              </a:ext>
            </a:extLst>
          </p:cNvPr>
          <p:cNvSpPr txBox="1"/>
          <p:nvPr/>
        </p:nvSpPr>
        <p:spPr>
          <a:xfrm>
            <a:off x="134338" y="6113234"/>
            <a:ext cx="1081041" cy="229743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15DE4349-F59C-7A74-8EC9-535E576E3C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2483" y="3503089"/>
            <a:ext cx="1607586" cy="46647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06883886-5BCE-64A2-F5EB-89A6D0EC78E4}"/>
              </a:ext>
            </a:extLst>
          </p:cNvPr>
          <p:cNvSpPr txBox="1"/>
          <p:nvPr/>
        </p:nvSpPr>
        <p:spPr>
          <a:xfrm>
            <a:off x="544398" y="3505843"/>
            <a:ext cx="793807" cy="1905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Trametinib [1uM]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939E7BA-EC1E-8D14-86EC-4812A4F83F8E}"/>
              </a:ext>
            </a:extLst>
          </p:cNvPr>
          <p:cNvSpPr txBox="1"/>
          <p:nvPr/>
        </p:nvSpPr>
        <p:spPr>
          <a:xfrm>
            <a:off x="643592" y="3621965"/>
            <a:ext cx="691215" cy="1905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Uridine [1mM]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B864553-7B52-218B-498A-DF6C89609A4C}"/>
              </a:ext>
            </a:extLst>
          </p:cNvPr>
          <p:cNvSpPr txBox="1"/>
          <p:nvPr/>
        </p:nvSpPr>
        <p:spPr>
          <a:xfrm>
            <a:off x="600312" y="3748703"/>
            <a:ext cx="734496" cy="1905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Glucose [5mM]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64650CC-2BF1-1E91-D909-3AABDB6EE755}"/>
              </a:ext>
            </a:extLst>
          </p:cNvPr>
          <p:cNvSpPr txBox="1"/>
          <p:nvPr/>
        </p:nvSpPr>
        <p:spPr>
          <a:xfrm>
            <a:off x="50398" y="3100989"/>
            <a:ext cx="1132675" cy="229743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91D4997E-B7D7-323E-74CF-4B4E776417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84990" y="3492316"/>
            <a:ext cx="1666040" cy="45899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46021C0-2B08-C18B-25C0-58611372D28B}"/>
              </a:ext>
            </a:extLst>
          </p:cNvPr>
          <p:cNvSpPr txBox="1"/>
          <p:nvPr/>
        </p:nvSpPr>
        <p:spPr>
          <a:xfrm>
            <a:off x="3988016" y="3485358"/>
            <a:ext cx="866706" cy="1905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Trametinib [1uM]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8B4E661-C247-8979-3342-C60A40C50AE2}"/>
              </a:ext>
            </a:extLst>
          </p:cNvPr>
          <p:cNvSpPr txBox="1"/>
          <p:nvPr/>
        </p:nvSpPr>
        <p:spPr>
          <a:xfrm>
            <a:off x="4101860" y="3601480"/>
            <a:ext cx="743968" cy="1905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Uridine [1mM]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DD4DA63-C939-3692-C7FE-60BC1E36D9DA}"/>
              </a:ext>
            </a:extLst>
          </p:cNvPr>
          <p:cNvSpPr txBox="1"/>
          <p:nvPr/>
        </p:nvSpPr>
        <p:spPr>
          <a:xfrm>
            <a:off x="4056590" y="3728216"/>
            <a:ext cx="791361" cy="1905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Glucose [5mM]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63502BC8-2AE6-73D9-91CD-679A779457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0120" y="6587686"/>
            <a:ext cx="1499734" cy="413174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CE05993F-C489-FB7C-FC32-C5EC60BEAD84}"/>
              </a:ext>
            </a:extLst>
          </p:cNvPr>
          <p:cNvSpPr txBox="1"/>
          <p:nvPr/>
        </p:nvSpPr>
        <p:spPr>
          <a:xfrm>
            <a:off x="-56542" y="6553267"/>
            <a:ext cx="1387654" cy="1905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Trametinib [1uM]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98BEF86-839A-89CB-866F-BA36FFE46808}"/>
              </a:ext>
            </a:extLst>
          </p:cNvPr>
          <p:cNvSpPr txBox="1"/>
          <p:nvPr/>
        </p:nvSpPr>
        <p:spPr>
          <a:xfrm>
            <a:off x="131077" y="6669390"/>
            <a:ext cx="1191142" cy="1905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Uridine [1mM]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563D824-E419-25CB-E2AB-0897DF49D71F}"/>
              </a:ext>
            </a:extLst>
          </p:cNvPr>
          <p:cNvSpPr txBox="1"/>
          <p:nvPr/>
        </p:nvSpPr>
        <p:spPr>
          <a:xfrm>
            <a:off x="57318" y="6796126"/>
            <a:ext cx="1267022" cy="1905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38" dirty="0">
                <a:latin typeface="Arial" panose="020B0604020202020204" pitchFamily="34" charset="0"/>
                <a:cs typeface="Arial" panose="020B0604020202020204" pitchFamily="34" charset="0"/>
              </a:rPr>
              <a:t>Glucose [5mM]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6763E7B-6295-7189-3E53-C3BD355423E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942" t="16074" r="20877" b="23134"/>
          <a:stretch/>
        </p:blipFill>
        <p:spPr>
          <a:xfrm>
            <a:off x="1161218" y="1650994"/>
            <a:ext cx="1866975" cy="1185446"/>
          </a:xfrm>
          <a:prstGeom prst="rect">
            <a:avLst/>
          </a:prstGeom>
          <a:ln w="12700"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11ECCD5-23E9-F01E-1B5E-D774BE565E6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51" t="3610" r="1035" b="5540"/>
          <a:stretch/>
        </p:blipFill>
        <p:spPr>
          <a:xfrm>
            <a:off x="1161218" y="2926011"/>
            <a:ext cx="1866974" cy="488275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3602674-63FD-2ACB-E67A-D51DD3A9F05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329" t="26035" r="17992" b="16486"/>
          <a:stretch/>
        </p:blipFill>
        <p:spPr>
          <a:xfrm>
            <a:off x="4562116" y="1683084"/>
            <a:ext cx="2059664" cy="1185646"/>
          </a:xfrm>
          <a:prstGeom prst="rect">
            <a:avLst/>
          </a:prstGeom>
          <a:ln w="12700">
            <a:noFill/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AA9A8FF-2A06-E063-A8BE-1A4272D3913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0444" t="44996" r="19834" b="33872"/>
          <a:stretch/>
        </p:blipFill>
        <p:spPr>
          <a:xfrm>
            <a:off x="4562116" y="2989266"/>
            <a:ext cx="2059664" cy="442886"/>
          </a:xfrm>
          <a:prstGeom prst="rect">
            <a:avLst/>
          </a:prstGeom>
          <a:ln w="12700">
            <a:noFill/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51D96285-5400-F246-621B-155CA255A52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7573" t="42293" r="24103" b="34508"/>
          <a:stretch/>
        </p:blipFill>
        <p:spPr>
          <a:xfrm>
            <a:off x="1229308" y="6056258"/>
            <a:ext cx="1741358" cy="422451"/>
          </a:xfrm>
          <a:prstGeom prst="rect">
            <a:avLst/>
          </a:prstGeom>
          <a:ln w="12700">
            <a:noFill/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2A2142AE-C9D3-3220-7931-D7D8BF5659B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2730" t="13460" r="14684" b="17984"/>
          <a:stretch/>
        </p:blipFill>
        <p:spPr>
          <a:xfrm>
            <a:off x="1235136" y="4757403"/>
            <a:ext cx="1735531" cy="1163635"/>
          </a:xfrm>
          <a:prstGeom prst="rect">
            <a:avLst/>
          </a:prstGeom>
          <a:ln w="12700">
            <a:noFill/>
          </a:ln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C1713710-B900-517C-A1D4-3083A9B153C1}"/>
              </a:ext>
            </a:extLst>
          </p:cNvPr>
          <p:cNvSpPr txBox="1"/>
          <p:nvPr/>
        </p:nvSpPr>
        <p:spPr>
          <a:xfrm>
            <a:off x="2902451" y="4406764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199FDEF-3A91-A373-ED9A-DFAC70DA96DC}"/>
              </a:ext>
            </a:extLst>
          </p:cNvPr>
          <p:cNvSpPr txBox="1"/>
          <p:nvPr/>
        </p:nvSpPr>
        <p:spPr>
          <a:xfrm>
            <a:off x="2918868" y="5139266"/>
            <a:ext cx="4732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44/4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73DC823-D59B-DB09-9C96-BF4B163AD2B6}"/>
              </a:ext>
            </a:extLst>
          </p:cNvPr>
          <p:cNvSpPr txBox="1"/>
          <p:nvPr/>
        </p:nvSpPr>
        <p:spPr>
          <a:xfrm>
            <a:off x="2948920" y="6188981"/>
            <a:ext cx="37702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FCFA14F-1CE3-CF58-A1FD-A3E3C32C7BFD}"/>
              </a:ext>
            </a:extLst>
          </p:cNvPr>
          <p:cNvSpPr txBox="1"/>
          <p:nvPr/>
        </p:nvSpPr>
        <p:spPr>
          <a:xfrm>
            <a:off x="6582626" y="1377580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1CF68E8-3DF8-F68F-52D4-F417BFC8E754}"/>
              </a:ext>
            </a:extLst>
          </p:cNvPr>
          <p:cNvSpPr txBox="1"/>
          <p:nvPr/>
        </p:nvSpPr>
        <p:spPr>
          <a:xfrm>
            <a:off x="6567298" y="2105907"/>
            <a:ext cx="4732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44/4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61ACD3D-ED9B-8B55-991E-97287BE18357}"/>
              </a:ext>
            </a:extLst>
          </p:cNvPr>
          <p:cNvSpPr txBox="1"/>
          <p:nvPr/>
        </p:nvSpPr>
        <p:spPr>
          <a:xfrm>
            <a:off x="2976494" y="1453341"/>
            <a:ext cx="45717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~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D4DF79E-0527-A563-9A08-673B9CD3C094}"/>
              </a:ext>
            </a:extLst>
          </p:cNvPr>
          <p:cNvSpPr txBox="1"/>
          <p:nvPr/>
        </p:nvSpPr>
        <p:spPr>
          <a:xfrm>
            <a:off x="3060890" y="2187483"/>
            <a:ext cx="312906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F5580DF-01A9-1E7C-D901-C565CE72FE7F}"/>
              </a:ext>
            </a:extLst>
          </p:cNvPr>
          <p:cNvSpPr/>
          <p:nvPr/>
        </p:nvSpPr>
        <p:spPr>
          <a:xfrm>
            <a:off x="1362147" y="2182616"/>
            <a:ext cx="1500021" cy="241769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BCF7A2DA-0C26-03A3-E85D-A96359BB486A}"/>
              </a:ext>
            </a:extLst>
          </p:cNvPr>
          <p:cNvSpPr/>
          <p:nvPr/>
        </p:nvSpPr>
        <p:spPr>
          <a:xfrm>
            <a:off x="1351609" y="3069924"/>
            <a:ext cx="1500021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B5D8271-570C-08BC-DD25-29D797219441}"/>
              </a:ext>
            </a:extLst>
          </p:cNvPr>
          <p:cNvSpPr/>
          <p:nvPr/>
        </p:nvSpPr>
        <p:spPr>
          <a:xfrm>
            <a:off x="4835494" y="2066572"/>
            <a:ext cx="1588839" cy="299889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92FC77C2-F226-F4EB-4518-B6B83F1877F6}"/>
              </a:ext>
            </a:extLst>
          </p:cNvPr>
          <p:cNvSpPr/>
          <p:nvPr/>
        </p:nvSpPr>
        <p:spPr>
          <a:xfrm>
            <a:off x="4824955" y="3049158"/>
            <a:ext cx="1588839" cy="299889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8C77026-D979-F298-41FD-BC9518417141}"/>
              </a:ext>
            </a:extLst>
          </p:cNvPr>
          <p:cNvSpPr/>
          <p:nvPr/>
        </p:nvSpPr>
        <p:spPr>
          <a:xfrm>
            <a:off x="1403069" y="5092072"/>
            <a:ext cx="1361554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0E84BEBF-3652-E3E0-31F7-7D0AC99A3B4E}"/>
              </a:ext>
            </a:extLst>
          </p:cNvPr>
          <p:cNvSpPr/>
          <p:nvPr/>
        </p:nvSpPr>
        <p:spPr>
          <a:xfrm>
            <a:off x="1415014" y="6112255"/>
            <a:ext cx="1361554" cy="286903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chemeClr val="tx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2CFC33B-34C6-3216-0B0B-7315466D51BF}"/>
              </a:ext>
            </a:extLst>
          </p:cNvPr>
          <p:cNvSpPr txBox="1"/>
          <p:nvPr/>
        </p:nvSpPr>
        <p:spPr>
          <a:xfrm>
            <a:off x="209904" y="166613"/>
            <a:ext cx="6858000" cy="563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3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 </a:t>
            </a:r>
            <a:r>
              <a:rPr lang="en-US" sz="1530" dirty="0">
                <a:latin typeface="Arial" panose="020B0604020202020204" pitchFamily="34" charset="0"/>
                <a:cs typeface="Arial" panose="020B0604020202020204" pitchFamily="34" charset="0"/>
              </a:rPr>
              <a:t>Full, uncropped western image for Extended Data Figure 8d (TU8988S).</a:t>
            </a:r>
          </a:p>
        </p:txBody>
      </p:sp>
    </p:spTree>
    <p:extLst>
      <p:ext uri="{BB962C8B-B14F-4D97-AF65-F5344CB8AC3E}">
        <p14:creationId xmlns:p14="http://schemas.microsoft.com/office/powerpoint/2010/main" val="45126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45</TotalTime>
  <Words>69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ton, Damien</dc:creator>
  <cp:lastModifiedBy>Lyssiotis, Costas</cp:lastModifiedBy>
  <cp:revision>27</cp:revision>
  <dcterms:created xsi:type="dcterms:W3CDTF">2022-08-08T03:19:06Z</dcterms:created>
  <dcterms:modified xsi:type="dcterms:W3CDTF">2023-03-31T02:45:04Z</dcterms:modified>
</cp:coreProperties>
</file>